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408" y="-32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28997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50783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3910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26177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51351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06692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34683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2814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9617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61940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70178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55E6FF-DF9A-44EE-AE06-7E4625F76C8B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DBDFC6-6C90-43E8-8CC8-3D6501B6DE3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64117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um 3">
            <a:extLst>
              <a:ext uri="{FF2B5EF4-FFF2-40B4-BE49-F238E27FC236}">
                <a16:creationId xmlns:a16="http://schemas.microsoft.com/office/drawing/2014/main" id="{1B708886-BF05-58B3-6A82-F449B1042C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4967149"/>
              </p:ext>
            </p:extLst>
          </p:nvPr>
        </p:nvGraphicFramePr>
        <p:xfrm>
          <a:off x="844796" y="8857362"/>
          <a:ext cx="2353338" cy="1738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755135" imgH="3037179" progId="Prism8.Document">
                  <p:embed/>
                </p:oleObj>
              </mc:Choice>
              <mc:Fallback>
                <p:oleObj name="Prism 8" r:id="rId2" imgW="3755135" imgH="3037179" progId="Prism8.Document">
                  <p:embed/>
                  <p:pic>
                    <p:nvPicPr>
                      <p:cNvPr id="12" name="Objektum 1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44796" y="8857362"/>
                        <a:ext cx="2353338" cy="173832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um 4">
            <a:extLst>
              <a:ext uri="{FF2B5EF4-FFF2-40B4-BE49-F238E27FC236}">
                <a16:creationId xmlns:a16="http://schemas.microsoft.com/office/drawing/2014/main" id="{A96EEB21-5B27-F879-8511-7519564918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3561089"/>
              </p:ext>
            </p:extLst>
          </p:nvPr>
        </p:nvGraphicFramePr>
        <p:xfrm>
          <a:off x="3677477" y="6870172"/>
          <a:ext cx="2329533" cy="1780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709398" imgH="3037179" progId="Prism8.Document">
                  <p:embed/>
                </p:oleObj>
              </mc:Choice>
              <mc:Fallback>
                <p:oleObj name="Prism 8" r:id="rId4" imgW="3709398" imgH="3037179" progId="Prism8.Document">
                  <p:embed/>
                  <p:pic>
                    <p:nvPicPr>
                      <p:cNvPr id="15" name="Objektum 1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77477" y="6870172"/>
                        <a:ext cx="2329533" cy="178083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um 5">
            <a:extLst>
              <a:ext uri="{FF2B5EF4-FFF2-40B4-BE49-F238E27FC236}">
                <a16:creationId xmlns:a16="http://schemas.microsoft.com/office/drawing/2014/main" id="{EA5892D9-C603-6BD8-A4A4-862CE9B5EF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5950984"/>
              </p:ext>
            </p:extLst>
          </p:nvPr>
        </p:nvGraphicFramePr>
        <p:xfrm>
          <a:off x="844796" y="604925"/>
          <a:ext cx="2353339" cy="1856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791509" imgH="2991439" progId="Prism8.Document">
                  <p:embed/>
                </p:oleObj>
              </mc:Choice>
              <mc:Fallback>
                <p:oleObj name="Prism 8" r:id="rId6" imgW="3791509" imgH="2991439" progId="Prism8.Document">
                  <p:embed/>
                  <p:pic>
                    <p:nvPicPr>
                      <p:cNvPr id="16" name="Objektum 15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44796" y="604925"/>
                        <a:ext cx="2353339" cy="1856654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um 6">
            <a:extLst>
              <a:ext uri="{FF2B5EF4-FFF2-40B4-BE49-F238E27FC236}">
                <a16:creationId xmlns:a16="http://schemas.microsoft.com/office/drawing/2014/main" id="{D662433B-0C59-A632-3DB4-3E34D40CB3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2354495"/>
              </p:ext>
            </p:extLst>
          </p:nvPr>
        </p:nvGraphicFramePr>
        <p:xfrm>
          <a:off x="864059" y="4779382"/>
          <a:ext cx="2353338" cy="18152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809876" imgH="2913646" progId="Prism8.Document">
                  <p:embed/>
                </p:oleObj>
              </mc:Choice>
              <mc:Fallback>
                <p:oleObj name="Prism 8" r:id="rId8" imgW="3809876" imgH="2913646" progId="Prism8.Document">
                  <p:embed/>
                  <p:pic>
                    <p:nvPicPr>
                      <p:cNvPr id="14" name="Objektum 13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64059" y="4779382"/>
                        <a:ext cx="2353338" cy="181520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um 7">
            <a:extLst>
              <a:ext uri="{FF2B5EF4-FFF2-40B4-BE49-F238E27FC236}">
                <a16:creationId xmlns:a16="http://schemas.microsoft.com/office/drawing/2014/main" id="{70DA20BB-70FA-4CDF-E5DF-07362A8CEC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9593776"/>
              </p:ext>
            </p:extLst>
          </p:nvPr>
        </p:nvGraphicFramePr>
        <p:xfrm>
          <a:off x="3664408" y="4782826"/>
          <a:ext cx="2329533" cy="1830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764138" imgH="2968390" progId="Prism8.Document">
                  <p:embed/>
                </p:oleObj>
              </mc:Choice>
              <mc:Fallback>
                <p:oleObj name="Prism 8" r:id="rId10" imgW="3764138" imgH="2968390" progId="Prism8.Document">
                  <p:embed/>
                  <p:pic>
                    <p:nvPicPr>
                      <p:cNvPr id="13" name="Objektum 12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64408" y="4782826"/>
                        <a:ext cx="2329533" cy="18300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um 13">
            <a:extLst>
              <a:ext uri="{FF2B5EF4-FFF2-40B4-BE49-F238E27FC236}">
                <a16:creationId xmlns:a16="http://schemas.microsoft.com/office/drawing/2014/main" id="{0ABC6B9E-7535-F3F2-4B3D-FFE91B51E7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4723179"/>
              </p:ext>
            </p:extLst>
          </p:nvPr>
        </p:nvGraphicFramePr>
        <p:xfrm>
          <a:off x="3651152" y="595358"/>
          <a:ext cx="2362052" cy="1856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691031" imgH="2968390" progId="Prism8.Document">
                  <p:embed/>
                </p:oleObj>
              </mc:Choice>
              <mc:Fallback>
                <p:oleObj name="Prism 8" r:id="rId12" imgW="3691031" imgH="2968390" progId="Prism8.Document">
                  <p:embed/>
                  <p:pic>
                    <p:nvPicPr>
                      <p:cNvPr id="4" name="Objektum 3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651152" y="595358"/>
                        <a:ext cx="2362052" cy="1856654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um 14">
            <a:extLst>
              <a:ext uri="{FF2B5EF4-FFF2-40B4-BE49-F238E27FC236}">
                <a16:creationId xmlns:a16="http://schemas.microsoft.com/office/drawing/2014/main" id="{CC4A151A-CAE9-9F59-C783-97231B8B3E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1511637"/>
              </p:ext>
            </p:extLst>
          </p:nvPr>
        </p:nvGraphicFramePr>
        <p:xfrm>
          <a:off x="864059" y="6835560"/>
          <a:ext cx="2353338" cy="1780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3791509" imgH="2950382" progId="Prism8.Document">
                  <p:embed/>
                </p:oleObj>
              </mc:Choice>
              <mc:Fallback>
                <p:oleObj name="Prism 8" r:id="rId14" imgW="3791509" imgH="2950382" progId="Prism8.Document">
                  <p:embed/>
                  <p:pic>
                    <p:nvPicPr>
                      <p:cNvPr id="5" name="Objektum 4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64059" y="6835560"/>
                        <a:ext cx="2353338" cy="178083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um 15">
            <a:extLst>
              <a:ext uri="{FF2B5EF4-FFF2-40B4-BE49-F238E27FC236}">
                <a16:creationId xmlns:a16="http://schemas.microsoft.com/office/drawing/2014/main" id="{0FD4E15F-DB41-EC6C-DFFF-A4E01021CC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2440934"/>
              </p:ext>
            </p:extLst>
          </p:nvPr>
        </p:nvGraphicFramePr>
        <p:xfrm>
          <a:off x="3683871" y="2664660"/>
          <a:ext cx="2323139" cy="18558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3691031" imgH="3037179" progId="Prism8.Document">
                  <p:embed/>
                </p:oleObj>
              </mc:Choice>
              <mc:Fallback>
                <p:oleObj name="Prism 8" r:id="rId16" imgW="3691031" imgH="3037179" progId="Prism8.Document">
                  <p:embed/>
                  <p:pic>
                    <p:nvPicPr>
                      <p:cNvPr id="6" name="Objektum 5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683871" y="2664660"/>
                        <a:ext cx="2323139" cy="185586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um 16">
            <a:extLst>
              <a:ext uri="{FF2B5EF4-FFF2-40B4-BE49-F238E27FC236}">
                <a16:creationId xmlns:a16="http://schemas.microsoft.com/office/drawing/2014/main" id="{A021E135-4AAB-25E8-6EEA-FE048D606D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3501548"/>
              </p:ext>
            </p:extLst>
          </p:nvPr>
        </p:nvGraphicFramePr>
        <p:xfrm>
          <a:off x="3651152" y="8857362"/>
          <a:ext cx="2313330" cy="1761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3682028" imgH="2959386" progId="Prism8.Document">
                  <p:embed/>
                </p:oleObj>
              </mc:Choice>
              <mc:Fallback>
                <p:oleObj name="Prism 8" r:id="rId18" imgW="3682028" imgH="2959386" progId="Prism8.Document">
                  <p:embed/>
                  <p:pic>
                    <p:nvPicPr>
                      <p:cNvPr id="7" name="Objektum 6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651152" y="8857362"/>
                        <a:ext cx="2313330" cy="176148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um 17">
            <a:extLst>
              <a:ext uri="{FF2B5EF4-FFF2-40B4-BE49-F238E27FC236}">
                <a16:creationId xmlns:a16="http://schemas.microsoft.com/office/drawing/2014/main" id="{C87E7DB4-8D74-D0A4-641D-D6662FDEFE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5620025"/>
              </p:ext>
            </p:extLst>
          </p:nvPr>
        </p:nvGraphicFramePr>
        <p:xfrm>
          <a:off x="864059" y="2702550"/>
          <a:ext cx="2353338" cy="18358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3782505" imgH="2950382" progId="Prism8.Document">
                  <p:embed/>
                </p:oleObj>
              </mc:Choice>
              <mc:Fallback>
                <p:oleObj name="Prism 8" r:id="rId20" imgW="3782505" imgH="2950382" progId="Prism8.Document">
                  <p:embed/>
                  <p:pic>
                    <p:nvPicPr>
                      <p:cNvPr id="8" name="Objektum 7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864059" y="2702550"/>
                        <a:ext cx="2353338" cy="183586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solidFill>
                          <a:srgbClr val="000000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Szövegdoboz 21">
            <a:extLst>
              <a:ext uri="{FF2B5EF4-FFF2-40B4-BE49-F238E27FC236}">
                <a16:creationId xmlns:a16="http://schemas.microsoft.com/office/drawing/2014/main" id="{0E8B2F5F-60C9-A740-DC68-1FFB5FB49AA0}"/>
              </a:ext>
            </a:extLst>
          </p:cNvPr>
          <p:cNvSpPr txBox="1"/>
          <p:nvPr/>
        </p:nvSpPr>
        <p:spPr>
          <a:xfrm>
            <a:off x="377106" y="10802047"/>
            <a:ext cx="6103788" cy="12483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</a:pPr>
            <a:r>
              <a:rPr lang="hu-HU" sz="900" b="1" dirty="0" err="1">
                <a:solidFill>
                  <a:prstClr val="black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Figure</a:t>
            </a:r>
            <a:r>
              <a:rPr lang="hu-HU" sz="900" b="1">
                <a:solidFill>
                  <a:prstClr val="black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 S</a:t>
            </a:r>
            <a:r>
              <a:rPr kumimoji="0" lang="hu-HU" sz="9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1</a:t>
            </a:r>
            <a:r>
              <a:rPr kumimoji="0" lang="hu-HU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. GSE42872. </a:t>
            </a:r>
            <a:r>
              <a:rPr lang="en-US" sz="900" i="1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pression data from BRAFV600E A375 melanoma cells treated with vehicle or vemurafenib.</a:t>
            </a:r>
            <a:r>
              <a:rPr kumimoji="0" lang="hu-HU" sz="9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1H1A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1H1B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1H2AB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1H2BB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1H2BF</a:t>
            </a:r>
            <a:r>
              <a:rPr lang="hu-HU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ST1H3A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T2B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HRF1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R17HG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hu-HU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R221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ere selected from those 200 genes that showed the greatest difference in expression leve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omparing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vemurafenib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melanoma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tatistical analysis was performed using the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Mann-Whitney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test. At a significance level of 5%, w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didn’t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observ</a:t>
            </a:r>
            <a:r>
              <a:rPr lang="hu-HU" sz="900" dirty="0">
                <a:solidFill>
                  <a:prstClr val="black"/>
                </a:solidFill>
                <a:latin typeface="Palatino Linotype" panose="02040502050505030304" pitchFamily="18" charset="0"/>
              </a:rPr>
              <a:t>e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 differences in the values ​​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hen comparing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melanoma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bgroup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p=0,100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all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T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n=3, NT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n=3,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1E2336"/>
                </a:solidFill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</a:t>
            </a:r>
            <a:r>
              <a:rPr lang="hu-HU" sz="900" dirty="0">
                <a:solidFill>
                  <a:srgbClr val="1E2336"/>
                </a:solidFill>
                <a:latin typeface="Palatino Linotype" panose="02040502050505030304" pitchFamily="18" charset="0"/>
              </a:rPr>
              <a:t>. </a:t>
            </a:r>
            <a:endParaRPr kumimoji="0" lang="pt-BR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93254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-té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7</TotalTime>
  <Words>131</Words>
  <Application>Microsoft Office PowerPoint</Application>
  <PresentationFormat>Szélesvásznú</PresentationFormat>
  <Paragraphs>1</Paragraphs>
  <Slides>1</Slides>
  <Notes>0</Notes>
  <HiddenSlides>0</HiddenSlides>
  <MMClips>0</MMClips>
  <ScaleCrop>false</ScaleCrop>
  <HeadingPairs>
    <vt:vector size="8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Beágyazott OLE kiszolgálók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-téma</vt:lpstr>
      <vt:lpstr>Prism 8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laudia Tóth</dc:creator>
  <cp:lastModifiedBy>Klaudia Tóth</cp:lastModifiedBy>
  <cp:revision>5</cp:revision>
  <dcterms:created xsi:type="dcterms:W3CDTF">2025-01-30T00:44:51Z</dcterms:created>
  <dcterms:modified xsi:type="dcterms:W3CDTF">2025-02-12T05:02:49Z</dcterms:modified>
</cp:coreProperties>
</file>